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43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60AD8-C547-4650-916F-C4A20F15F848}" type="datetimeFigureOut">
              <a:rPr lang="en-US" smtClean="0"/>
              <a:t>4/21/2016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4C68E-32A3-42FE-BFD0-18025A6B57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81063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60AD8-C547-4650-916F-C4A20F15F848}" type="datetimeFigureOut">
              <a:rPr lang="en-US" smtClean="0"/>
              <a:t>4/21/2016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4C68E-32A3-42FE-BFD0-18025A6B57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5133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60AD8-C547-4650-916F-C4A20F15F848}" type="datetimeFigureOut">
              <a:rPr lang="en-US" smtClean="0"/>
              <a:t>4/21/2016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4C68E-32A3-42FE-BFD0-18025A6B57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4141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60AD8-C547-4650-916F-C4A20F15F848}" type="datetimeFigureOut">
              <a:rPr lang="en-US" smtClean="0"/>
              <a:t>4/21/2016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4C68E-32A3-42FE-BFD0-18025A6B57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34123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60AD8-C547-4650-916F-C4A20F15F848}" type="datetimeFigureOut">
              <a:rPr lang="en-US" smtClean="0"/>
              <a:t>4/21/2016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4C68E-32A3-42FE-BFD0-18025A6B57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11069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60AD8-C547-4650-916F-C4A20F15F848}" type="datetimeFigureOut">
              <a:rPr lang="en-US" smtClean="0"/>
              <a:t>4/21/2016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4C68E-32A3-42FE-BFD0-18025A6B57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48994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60AD8-C547-4650-916F-C4A20F15F848}" type="datetimeFigureOut">
              <a:rPr lang="en-US" smtClean="0"/>
              <a:t>4/21/2016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4C68E-32A3-42FE-BFD0-18025A6B57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08744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60AD8-C547-4650-916F-C4A20F15F848}" type="datetimeFigureOut">
              <a:rPr lang="en-US" smtClean="0"/>
              <a:t>4/21/2016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4C68E-32A3-42FE-BFD0-18025A6B57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99907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60AD8-C547-4650-916F-C4A20F15F848}" type="datetimeFigureOut">
              <a:rPr lang="en-US" smtClean="0"/>
              <a:t>4/21/2016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4C68E-32A3-42FE-BFD0-18025A6B57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33098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60AD8-C547-4650-916F-C4A20F15F848}" type="datetimeFigureOut">
              <a:rPr lang="en-US" smtClean="0"/>
              <a:t>4/21/2016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4C68E-32A3-42FE-BFD0-18025A6B57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80624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60AD8-C547-4650-916F-C4A20F15F848}" type="datetimeFigureOut">
              <a:rPr lang="en-US" smtClean="0"/>
              <a:t>4/21/2016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4C68E-32A3-42FE-BFD0-18025A6B57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87038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260AD8-C547-4650-916F-C4A20F15F848}" type="datetimeFigureOut">
              <a:rPr lang="en-US" smtClean="0"/>
              <a:t>4/21/2016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B4C68E-32A3-42FE-BFD0-18025A6B57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0967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hteck 4"/>
          <p:cNvSpPr/>
          <p:nvPr/>
        </p:nvSpPr>
        <p:spPr>
          <a:xfrm>
            <a:off x="689955" y="195719"/>
            <a:ext cx="756458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. </a:t>
            </a:r>
            <a:r>
              <a:rPr lang="en-US" sz="12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3.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targeting promotes the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radiosensitizing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effect of rapamycin in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non-responder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cells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45685" y="1008199"/>
            <a:ext cx="4102608" cy="49580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483992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</Words>
  <Application>Microsoft Office PowerPoint</Application>
  <PresentationFormat>Breitbild</PresentationFormat>
  <Paragraphs>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htoul04a</dc:creator>
  <cp:lastModifiedBy>MT</cp:lastModifiedBy>
  <cp:revision>16</cp:revision>
  <dcterms:created xsi:type="dcterms:W3CDTF">2015-08-27T14:11:55Z</dcterms:created>
  <dcterms:modified xsi:type="dcterms:W3CDTF">2016-04-21T10:28:21Z</dcterms:modified>
</cp:coreProperties>
</file>